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4"/>
  </p:sldMasterIdLst>
  <p:notesMasterIdLst>
    <p:notesMasterId r:id="rId9"/>
  </p:notesMasterIdLst>
  <p:sldIdLst>
    <p:sldId id="262" r:id="rId5"/>
    <p:sldId id="268" r:id="rId6"/>
    <p:sldId id="275" r:id="rId7"/>
    <p:sldId id="274" r:id="rId8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13EDE17-47C2-7F8A-21DE-AB370ED93B94}" name="Calu, Donna" initials="CD" userId="S::DCalu@som.umaryland.edu::27b43ccf-671c-4eb0-9550-9033b4f9245b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21" autoAdjust="0"/>
    <p:restoredTop sz="94660"/>
  </p:normalViewPr>
  <p:slideViewPr>
    <p:cSldViewPr snapToGrid="0">
      <p:cViewPr>
        <p:scale>
          <a:sx n="100" d="100"/>
          <a:sy n="100" d="100"/>
        </p:scale>
        <p:origin x="1200" y="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notesMaster" Target="notesMasters/notesMaster1.xml"/><Relationship Id="rId14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7D2F5F8-76F2-4EC9-8CD0-123B69E28310}" type="datetimeFigureOut">
              <a:rPr lang="en-US" smtClean="0"/>
              <a:t>8/5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7D38F53-1721-4E29-AA13-AB1C2CE966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4052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1pPr>
    <a:lvl2pPr marL="509412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2pPr>
    <a:lvl3pPr marL="1018824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3pPr>
    <a:lvl4pPr marL="1528237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4pPr>
    <a:lvl5pPr marL="2037649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5pPr>
    <a:lvl6pPr marL="2547061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6pPr>
    <a:lvl7pPr marL="3056473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7pPr>
    <a:lvl8pPr marL="3565886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8pPr>
    <a:lvl9pPr marL="4075298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6EDF2-9648-4428-B0DD-AFE798D92F7C}" type="datetimeFigureOut">
              <a:rPr lang="en-US" smtClean="0"/>
              <a:t>8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E33C6-6170-4CA5-A2C8-624A852FFD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62573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6EDF2-9648-4428-B0DD-AFE798D92F7C}" type="datetimeFigureOut">
              <a:rPr lang="en-US" smtClean="0"/>
              <a:t>8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E33C6-6170-4CA5-A2C8-624A852FFD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45442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6EDF2-9648-4428-B0DD-AFE798D92F7C}" type="datetimeFigureOut">
              <a:rPr lang="en-US" smtClean="0"/>
              <a:t>8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E33C6-6170-4CA5-A2C8-624A852FFD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00185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6EDF2-9648-4428-B0DD-AFE798D92F7C}" type="datetimeFigureOut">
              <a:rPr lang="en-US" smtClean="0"/>
              <a:t>8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E33C6-6170-4CA5-A2C8-624A852FFD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82938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6EDF2-9648-4428-B0DD-AFE798D92F7C}" type="datetimeFigureOut">
              <a:rPr lang="en-US" smtClean="0"/>
              <a:t>8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E33C6-6170-4CA5-A2C8-624A852FFD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41981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6EDF2-9648-4428-B0DD-AFE798D92F7C}" type="datetimeFigureOut">
              <a:rPr lang="en-US" smtClean="0"/>
              <a:t>8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E33C6-6170-4CA5-A2C8-624A852FFD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42503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6EDF2-9648-4428-B0DD-AFE798D92F7C}" type="datetimeFigureOut">
              <a:rPr lang="en-US" smtClean="0"/>
              <a:t>8/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E33C6-6170-4CA5-A2C8-624A852FFD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7399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6EDF2-9648-4428-B0DD-AFE798D92F7C}" type="datetimeFigureOut">
              <a:rPr lang="en-US" smtClean="0"/>
              <a:t>8/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E33C6-6170-4CA5-A2C8-624A852FFD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256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6EDF2-9648-4428-B0DD-AFE798D92F7C}" type="datetimeFigureOut">
              <a:rPr lang="en-US" smtClean="0"/>
              <a:t>8/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E33C6-6170-4CA5-A2C8-624A852FFD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36214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6EDF2-9648-4428-B0DD-AFE798D92F7C}" type="datetimeFigureOut">
              <a:rPr lang="en-US" smtClean="0"/>
              <a:t>8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E33C6-6170-4CA5-A2C8-624A852FFD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7584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6EDF2-9648-4428-B0DD-AFE798D92F7C}" type="datetimeFigureOut">
              <a:rPr lang="en-US" smtClean="0"/>
              <a:t>8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E33C6-6170-4CA5-A2C8-624A852FFD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73583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56EDF2-9648-4428-B0DD-AFE798D92F7C}" type="datetimeFigureOut">
              <a:rPr lang="en-US" smtClean="0"/>
              <a:t>8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4E33C6-6170-4CA5-A2C8-624A852FFD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05098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 descr="Chart, bar chart&#10;&#10;Description automatically generated">
            <a:extLst>
              <a:ext uri="{FF2B5EF4-FFF2-40B4-BE49-F238E27FC236}">
                <a16:creationId xmlns:a16="http://schemas.microsoft.com/office/drawing/2014/main" id="{6758BC44-C358-BCC3-BBEA-7F3D0DC5607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370" y="0"/>
            <a:ext cx="3140955" cy="1760437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0" y="83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D30DD54-A3B2-8D2F-6B20-186468D68101}"/>
              </a:ext>
            </a:extLst>
          </p:cNvPr>
          <p:cNvSpPr txBox="1"/>
          <p:nvPr/>
        </p:nvSpPr>
        <p:spPr>
          <a:xfrm>
            <a:off x="1" y="4030441"/>
            <a:ext cx="6857999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2-1. Consumption and response in a non-sated test do not change due to Sex or Treatment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ata are represented as group data (bars; mean ± SEM)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A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 a non-sated extinction test identical in duration to the sated tests, we observed no effects of CB1R inhibition on total behavior for male or female rats.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B,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In a post-session choice test, we gave rats 30 minutes of access to both outcomes and they consumed less of the outcome they were stated on, regardless of Sex or Treatment. *p&lt;0.05 ***p&lt;0.01</a:t>
            </a:r>
          </a:p>
          <a:p>
            <a:pPr algn="l"/>
            <a:endParaRPr 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endParaRPr 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6305480F-959B-0163-0A30-A98CE3CF0253}"/>
              </a:ext>
            </a:extLst>
          </p:cNvPr>
          <p:cNvGrpSpPr/>
          <p:nvPr/>
        </p:nvGrpSpPr>
        <p:grpSpPr>
          <a:xfrm>
            <a:off x="121367" y="1667462"/>
            <a:ext cx="3595015" cy="2192245"/>
            <a:chOff x="138817" y="298574"/>
            <a:chExt cx="4250015" cy="2591665"/>
          </a:xfrm>
        </p:grpSpPr>
        <p:pic>
          <p:nvPicPr>
            <p:cNvPr id="14" name="Picture 13" descr="A graph of different sizes of people&#10;&#10;Description automatically generated with medium confidence">
              <a:extLst>
                <a:ext uri="{FF2B5EF4-FFF2-40B4-BE49-F238E27FC236}">
                  <a16:creationId xmlns:a16="http://schemas.microsoft.com/office/drawing/2014/main" id="{28F32D4B-856D-A46E-202C-509FE17DDB4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4903"/>
            <a:stretch/>
          </p:blipFill>
          <p:spPr>
            <a:xfrm>
              <a:off x="138817" y="535737"/>
              <a:ext cx="3167405" cy="2354502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EA724CFC-A1B7-4A51-F888-7A10D3025755}"/>
                </a:ext>
              </a:extLst>
            </p:cNvPr>
            <p:cNvSpPr txBox="1"/>
            <p:nvPr/>
          </p:nvSpPr>
          <p:spPr>
            <a:xfrm>
              <a:off x="2762125" y="912497"/>
              <a:ext cx="574291" cy="2728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7B01A1EE-B4BD-1546-FC41-515E45EF7659}"/>
                </a:ext>
              </a:extLst>
            </p:cNvPr>
            <p:cNvSpPr txBox="1"/>
            <p:nvPr/>
          </p:nvSpPr>
          <p:spPr>
            <a:xfrm>
              <a:off x="2152329" y="903216"/>
              <a:ext cx="574291" cy="2728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B2C7912-8985-24BA-A67F-88A494693876}"/>
                </a:ext>
              </a:extLst>
            </p:cNvPr>
            <p:cNvSpPr txBox="1"/>
            <p:nvPr/>
          </p:nvSpPr>
          <p:spPr>
            <a:xfrm>
              <a:off x="1568079" y="912635"/>
              <a:ext cx="574291" cy="2728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34360B7-37C8-7A95-5E47-5E8D3E4E21E4}"/>
                </a:ext>
              </a:extLst>
            </p:cNvPr>
            <p:cNvSpPr txBox="1"/>
            <p:nvPr/>
          </p:nvSpPr>
          <p:spPr>
            <a:xfrm>
              <a:off x="971372" y="921918"/>
              <a:ext cx="574291" cy="2728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pic>
          <p:nvPicPr>
            <p:cNvPr id="16" name="Picture 15" descr="A graph of different sizes of people&#10;&#10;Description automatically generated with medium confidence">
              <a:extLst>
                <a:ext uri="{FF2B5EF4-FFF2-40B4-BE49-F238E27FC236}">
                  <a16:creationId xmlns:a16="http://schemas.microsoft.com/office/drawing/2014/main" id="{BDBF0377-F4F9-8A25-0301-F114CF1B958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287" t="9755" b="64599"/>
            <a:stretch/>
          </p:blipFill>
          <p:spPr>
            <a:xfrm>
              <a:off x="2797125" y="298574"/>
              <a:ext cx="1591707" cy="603848"/>
            </a:xfrm>
            <a:prstGeom prst="rect">
              <a:avLst/>
            </a:prstGeom>
          </p:spPr>
        </p:pic>
      </p:grpSp>
      <p:sp>
        <p:nvSpPr>
          <p:cNvPr id="6" name="TextBox 5"/>
          <p:cNvSpPr txBox="1"/>
          <p:nvPr/>
        </p:nvSpPr>
        <p:spPr>
          <a:xfrm>
            <a:off x="0" y="176896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57F8AB2F-13A2-E153-3251-0491CB2659DC}"/>
              </a:ext>
            </a:extLst>
          </p:cNvPr>
          <p:cNvGrpSpPr/>
          <p:nvPr/>
        </p:nvGrpSpPr>
        <p:grpSpPr>
          <a:xfrm>
            <a:off x="3656994" y="1786280"/>
            <a:ext cx="159268" cy="155391"/>
            <a:chOff x="7216091" y="3998321"/>
            <a:chExt cx="159268" cy="155391"/>
          </a:xfrm>
        </p:grpSpPr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B37204AD-E127-7F09-ABB6-25B26B37EC55}"/>
                </a:ext>
              </a:extLst>
            </p:cNvPr>
            <p:cNvCxnSpPr>
              <a:cxnSpLocks/>
            </p:cNvCxnSpPr>
            <p:nvPr/>
          </p:nvCxnSpPr>
          <p:spPr>
            <a:xfrm>
              <a:off x="7375359" y="4006516"/>
              <a:ext cx="0" cy="147196"/>
            </a:xfrm>
            <a:prstGeom prst="line">
              <a:avLst/>
            </a:prstGeom>
            <a:ln w="952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B9C921FB-7E39-9180-7846-A2CE6ED4740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216626" y="4151734"/>
              <a:ext cx="156410" cy="0"/>
            </a:xfrm>
            <a:prstGeom prst="line">
              <a:avLst/>
            </a:prstGeom>
            <a:ln w="952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283AAC1C-5AA6-2678-60B2-574A4E7E588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216091" y="3998321"/>
              <a:ext cx="156410" cy="0"/>
            </a:xfrm>
            <a:prstGeom prst="line">
              <a:avLst/>
            </a:prstGeom>
            <a:ln w="952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D1E5C9FF-FB3B-2FDD-09DC-51428DCFF0C2}"/>
              </a:ext>
            </a:extLst>
          </p:cNvPr>
          <p:cNvSpPr txBox="1"/>
          <p:nvPr/>
        </p:nvSpPr>
        <p:spPr>
          <a:xfrm>
            <a:off x="3776024" y="1768958"/>
            <a:ext cx="3779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33661268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 descr="A black background with white dots with Gallery Arcturus in the background&#10;&#10;Description automatically generated">
            <a:extLst>
              <a:ext uri="{FF2B5EF4-FFF2-40B4-BE49-F238E27FC236}">
                <a16:creationId xmlns:a16="http://schemas.microsoft.com/office/drawing/2014/main" id="{6C0EF60B-82DC-CC33-11A9-52242DCBD4D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6" t="39127" r="63177" b="35967"/>
          <a:stretch/>
        </p:blipFill>
        <p:spPr>
          <a:xfrm>
            <a:off x="45677" y="153885"/>
            <a:ext cx="1890567" cy="1507835"/>
          </a:xfrm>
          <a:prstGeom prst="rect">
            <a:avLst/>
          </a:prstGeom>
        </p:spPr>
      </p:pic>
      <p:pic>
        <p:nvPicPr>
          <p:cNvPr id="20" name="Picture 19" descr="A black background with white dots with Gallery Arcturus in the background&#10;&#10;Description automatically generated">
            <a:extLst>
              <a:ext uri="{FF2B5EF4-FFF2-40B4-BE49-F238E27FC236}">
                <a16:creationId xmlns:a16="http://schemas.microsoft.com/office/drawing/2014/main" id="{C3D3EC77-D213-466C-2A87-536E9268705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32" t="75354" r="63575" b="-260"/>
          <a:stretch/>
        </p:blipFill>
        <p:spPr>
          <a:xfrm>
            <a:off x="9" y="1555796"/>
            <a:ext cx="1890567" cy="150783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FD71548-4D34-1251-363C-D2CDCE1A3836}"/>
              </a:ext>
            </a:extLst>
          </p:cNvPr>
          <p:cNvSpPr txBox="1"/>
          <p:nvPr/>
        </p:nvSpPr>
        <p:spPr>
          <a:xfrm>
            <a:off x="0" y="0"/>
            <a:ext cx="913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93B7C39-73A6-CDC2-468B-FF89B9D7AE34}"/>
              </a:ext>
            </a:extLst>
          </p:cNvPr>
          <p:cNvSpPr txBox="1"/>
          <p:nvPr/>
        </p:nvSpPr>
        <p:spPr>
          <a:xfrm>
            <a:off x="0" y="1455192"/>
            <a:ext cx="913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420D6E2-1026-9D2B-CCDD-6CF0D7A99891}"/>
              </a:ext>
            </a:extLst>
          </p:cNvPr>
          <p:cNvSpPr txBox="1"/>
          <p:nvPr/>
        </p:nvSpPr>
        <p:spPr>
          <a:xfrm>
            <a:off x="0" y="3256316"/>
            <a:ext cx="6858000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2-2. Intra-DMS Rimonabant does not impact Pavlovian Conditioned Approach in reinforced PLA sessions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ata are represented as per day group averages; mean ± SEM. All rats received intracranial infusion of vehicle or Rimonabant (1µg/µl, 2 µg/µl) 10 min prior to the start of the PLA session.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A,B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e observed no significant interactions with Treatment for Tracking (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or Sex (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righ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on lever or foodcup contacts. We observed a significant main effect of Sex on lever contacts. *p=0.05</a:t>
            </a:r>
          </a:p>
          <a:p>
            <a:pPr algn="l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 descr="A black background with white dots with Gallery Arcturus in the background&#10;&#10;Description automatically generated">
            <a:extLst>
              <a:ext uri="{FF2B5EF4-FFF2-40B4-BE49-F238E27FC236}">
                <a16:creationId xmlns:a16="http://schemas.microsoft.com/office/drawing/2014/main" id="{B7DFB4DD-4CC6-FACD-F249-FAF50D66160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179" t="39127" r="51288" b="53526"/>
          <a:stretch/>
        </p:blipFill>
        <p:spPr>
          <a:xfrm>
            <a:off x="1689750" y="13752"/>
            <a:ext cx="492983" cy="444763"/>
          </a:xfrm>
          <a:prstGeom prst="rect">
            <a:avLst/>
          </a:prstGeom>
        </p:spPr>
      </p:pic>
      <p:pic>
        <p:nvPicPr>
          <p:cNvPr id="4" name="Picture 3" descr="A black background with white dots with Gallery Arcturus in the background&#10;&#10;Description automatically generated">
            <a:extLst>
              <a:ext uri="{FF2B5EF4-FFF2-40B4-BE49-F238E27FC236}">
                <a16:creationId xmlns:a16="http://schemas.microsoft.com/office/drawing/2014/main" id="{B51E1916-B923-AC97-1EAC-ECD9A657263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311" t="37026" r="12132" b="38068"/>
          <a:stretch/>
        </p:blipFill>
        <p:spPr>
          <a:xfrm>
            <a:off x="2182738" y="14732"/>
            <a:ext cx="1890567" cy="1507835"/>
          </a:xfrm>
          <a:prstGeom prst="rect">
            <a:avLst/>
          </a:prstGeom>
        </p:spPr>
      </p:pic>
      <p:pic>
        <p:nvPicPr>
          <p:cNvPr id="7" name="Picture 6" descr="A black background with white dots with Gallery Arcturus in the background&#10;&#10;Description automatically generated">
            <a:extLst>
              <a:ext uri="{FF2B5EF4-FFF2-40B4-BE49-F238E27FC236}">
                <a16:creationId xmlns:a16="http://schemas.microsoft.com/office/drawing/2014/main" id="{B84EF16F-DC3E-4BE1-28E1-9FC0FB156F5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764" t="38995" r="1703" b="53658"/>
          <a:stretch/>
        </p:blipFill>
        <p:spPr>
          <a:xfrm>
            <a:off x="3826809" y="13752"/>
            <a:ext cx="492983" cy="444763"/>
          </a:xfrm>
          <a:prstGeom prst="rect">
            <a:avLst/>
          </a:prstGeom>
        </p:spPr>
      </p:pic>
      <p:pic>
        <p:nvPicPr>
          <p:cNvPr id="8" name="Picture 7" descr="A black background with white dots with Gallery Arcturus in the background&#10;&#10;Description automatically generated">
            <a:extLst>
              <a:ext uri="{FF2B5EF4-FFF2-40B4-BE49-F238E27FC236}">
                <a16:creationId xmlns:a16="http://schemas.microsoft.com/office/drawing/2014/main" id="{556C8C47-9D8A-A41C-75C5-2A303E24619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181" t="73133" r="12262" b="1961"/>
          <a:stretch/>
        </p:blipFill>
        <p:spPr>
          <a:xfrm>
            <a:off x="2182742" y="1454841"/>
            <a:ext cx="1890567" cy="1507835"/>
          </a:xfrm>
          <a:prstGeom prst="rect">
            <a:avLst/>
          </a:prstGeom>
        </p:spPr>
      </p:pic>
      <p:pic>
        <p:nvPicPr>
          <p:cNvPr id="9" name="Picture 8" descr="A black background with white dots with Gallery Arcturus in the background&#10;&#10;Description automatically generated">
            <a:extLst>
              <a:ext uri="{FF2B5EF4-FFF2-40B4-BE49-F238E27FC236}">
                <a16:creationId xmlns:a16="http://schemas.microsoft.com/office/drawing/2014/main" id="{A150C1D6-1C3D-52B6-529A-0743E373CF7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179" t="39127" r="51288" b="53526"/>
          <a:stretch/>
        </p:blipFill>
        <p:spPr>
          <a:xfrm>
            <a:off x="1684029" y="1525641"/>
            <a:ext cx="492983" cy="444763"/>
          </a:xfrm>
          <a:prstGeom prst="rect">
            <a:avLst/>
          </a:prstGeom>
        </p:spPr>
      </p:pic>
      <p:pic>
        <p:nvPicPr>
          <p:cNvPr id="10" name="Picture 9" descr="A black background with white dots with Gallery Arcturus in the background&#10;&#10;Description automatically generated">
            <a:extLst>
              <a:ext uri="{FF2B5EF4-FFF2-40B4-BE49-F238E27FC236}">
                <a16:creationId xmlns:a16="http://schemas.microsoft.com/office/drawing/2014/main" id="{80B46162-29CC-F22A-9AD0-821163A8510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764" t="38995" r="1703" b="53658"/>
          <a:stretch/>
        </p:blipFill>
        <p:spPr>
          <a:xfrm>
            <a:off x="3821086" y="1525641"/>
            <a:ext cx="492983" cy="444763"/>
          </a:xfrm>
          <a:prstGeom prst="rect">
            <a:avLst/>
          </a:prstGeom>
        </p:spPr>
      </p:pic>
      <p:grpSp>
        <p:nvGrpSpPr>
          <p:cNvPr id="11" name="Group 10">
            <a:extLst>
              <a:ext uri="{FF2B5EF4-FFF2-40B4-BE49-F238E27FC236}">
                <a16:creationId xmlns:a16="http://schemas.microsoft.com/office/drawing/2014/main" id="{B3408DAA-B274-75F3-E6BB-8262AB2643D0}"/>
              </a:ext>
            </a:extLst>
          </p:cNvPr>
          <p:cNvGrpSpPr/>
          <p:nvPr/>
        </p:nvGrpSpPr>
        <p:grpSpPr>
          <a:xfrm>
            <a:off x="4314069" y="156657"/>
            <a:ext cx="156639" cy="153068"/>
            <a:chOff x="7218949" y="4000644"/>
            <a:chExt cx="156638" cy="153068"/>
          </a:xfrm>
        </p:grpSpPr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08538F76-462F-6A7B-F8CD-644C8269A92D}"/>
                </a:ext>
              </a:extLst>
            </p:cNvPr>
            <p:cNvCxnSpPr>
              <a:cxnSpLocks/>
            </p:cNvCxnSpPr>
            <p:nvPr/>
          </p:nvCxnSpPr>
          <p:spPr>
            <a:xfrm>
              <a:off x="7375359" y="4006516"/>
              <a:ext cx="0" cy="147196"/>
            </a:xfrm>
            <a:prstGeom prst="line">
              <a:avLst/>
            </a:prstGeom>
            <a:ln w="952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1182BB75-96AB-A911-0887-8DE501AFBB3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218949" y="4151734"/>
              <a:ext cx="156410" cy="0"/>
            </a:xfrm>
            <a:prstGeom prst="line">
              <a:avLst/>
            </a:prstGeom>
            <a:ln w="952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21A4A3C6-C802-8000-5E08-477C895B70D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219177" y="4000644"/>
              <a:ext cx="156410" cy="0"/>
            </a:xfrm>
            <a:prstGeom prst="line">
              <a:avLst/>
            </a:prstGeom>
            <a:ln w="952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809BDE58-8D03-BA0A-9F34-021A1A6451C0}"/>
              </a:ext>
            </a:extLst>
          </p:cNvPr>
          <p:cNvSpPr txBox="1"/>
          <p:nvPr/>
        </p:nvSpPr>
        <p:spPr>
          <a:xfrm>
            <a:off x="4408176" y="137982"/>
            <a:ext cx="3779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3471564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88CA3EB5-4404-5E97-47E2-FFB5FFF6049C}"/>
              </a:ext>
            </a:extLst>
          </p:cNvPr>
          <p:cNvGrpSpPr/>
          <p:nvPr/>
        </p:nvGrpSpPr>
        <p:grpSpPr>
          <a:xfrm>
            <a:off x="0" y="216661"/>
            <a:ext cx="4117699" cy="1723072"/>
            <a:chOff x="150038" y="456631"/>
            <a:chExt cx="4117699" cy="1723072"/>
          </a:xfrm>
        </p:grpSpPr>
        <p:pic>
          <p:nvPicPr>
            <p:cNvPr id="26" name="Picture 25" descr="A screenshot of a video game&#10;&#10;Description automatically generated">
              <a:extLst>
                <a:ext uri="{FF2B5EF4-FFF2-40B4-BE49-F238E27FC236}">
                  <a16:creationId xmlns:a16="http://schemas.microsoft.com/office/drawing/2014/main" id="{CC71F27C-46D2-EE97-FA3F-2AF87601468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2750" b="61145"/>
            <a:stretch/>
          </p:blipFill>
          <p:spPr>
            <a:xfrm>
              <a:off x="150038" y="456631"/>
              <a:ext cx="3409671" cy="1723072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737CD077-CBC2-B4E7-F66C-89F6FDE6955D}"/>
                </a:ext>
              </a:extLst>
            </p:cNvPr>
            <p:cNvSpPr txBox="1"/>
            <p:nvPr/>
          </p:nvSpPr>
          <p:spPr>
            <a:xfrm>
              <a:off x="887577" y="1072570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</a:p>
          </p:txBody>
        </p:sp>
        <p:pic>
          <p:nvPicPr>
            <p:cNvPr id="24" name="Picture 23" descr="A screenshot of a video game&#10;&#10;Description automatically generated">
              <a:extLst>
                <a:ext uri="{FF2B5EF4-FFF2-40B4-BE49-F238E27FC236}">
                  <a16:creationId xmlns:a16="http://schemas.microsoft.com/office/drawing/2014/main" id="{3243472D-0D99-EB74-946F-A902450EDA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999" t="10355" r="3112" b="67386"/>
            <a:stretch/>
          </p:blipFill>
          <p:spPr>
            <a:xfrm>
              <a:off x="3353337" y="469761"/>
              <a:ext cx="914400" cy="494877"/>
            </a:xfrm>
            <a:prstGeom prst="rect">
              <a:avLst/>
            </a:prstGeom>
          </p:spPr>
        </p:pic>
      </p:grpSp>
      <p:pic>
        <p:nvPicPr>
          <p:cNvPr id="27" name="Picture 26" descr="A screenshot of a video game&#10;&#10;Description automatically generated">
            <a:extLst>
              <a:ext uri="{FF2B5EF4-FFF2-40B4-BE49-F238E27FC236}">
                <a16:creationId xmlns:a16="http://schemas.microsoft.com/office/drawing/2014/main" id="{3CE2512B-BA98-305E-2768-1D1A5BF36B0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r="23230" b="60547"/>
          <a:stretch/>
        </p:blipFill>
        <p:spPr>
          <a:xfrm>
            <a:off x="20767" y="2055408"/>
            <a:ext cx="3409672" cy="1725412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336B10BF-5FF6-FA7E-B2BC-68C74BA66218}"/>
              </a:ext>
            </a:extLst>
          </p:cNvPr>
          <p:cNvSpPr txBox="1"/>
          <p:nvPr/>
        </p:nvSpPr>
        <p:spPr>
          <a:xfrm>
            <a:off x="967091" y="387415"/>
            <a:ext cx="606025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1" b="1" dirty="0">
                <a:latin typeface="Arial" panose="020B0604020202020204" pitchFamily="34" charset="0"/>
                <a:cs typeface="Arial" panose="020B0604020202020204" pitchFamily="34" charset="0"/>
              </a:rPr>
              <a:t>Male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311C0FA-6B67-C988-D569-D6CB6699D3D4}"/>
              </a:ext>
            </a:extLst>
          </p:cNvPr>
          <p:cNvSpPr txBox="1"/>
          <p:nvPr/>
        </p:nvSpPr>
        <p:spPr>
          <a:xfrm>
            <a:off x="2386128" y="387414"/>
            <a:ext cx="1511771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1" b="1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  <a:r>
              <a:rPr lang="en-US" sz="591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1D7D7B6-297F-6920-1599-8F3F6B0F636A}"/>
              </a:ext>
            </a:extLst>
          </p:cNvPr>
          <p:cNvSpPr txBox="1"/>
          <p:nvPr/>
        </p:nvSpPr>
        <p:spPr>
          <a:xfrm>
            <a:off x="77983" y="192455"/>
            <a:ext cx="913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BB4B245-D213-4268-7C3A-7D09FF716E17}"/>
              </a:ext>
            </a:extLst>
          </p:cNvPr>
          <p:cNvSpPr txBox="1"/>
          <p:nvPr/>
        </p:nvSpPr>
        <p:spPr>
          <a:xfrm>
            <a:off x="1991959" y="188785"/>
            <a:ext cx="913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" name="Content Placeholder 2">
            <a:extLst>
              <a:ext uri="{FF2B5EF4-FFF2-40B4-BE49-F238E27FC236}">
                <a16:creationId xmlns:a16="http://schemas.microsoft.com/office/drawing/2014/main" id="{AC4EEF2A-ADDC-A9C0-A1A7-3E034087CBE1}"/>
              </a:ext>
            </a:extLst>
          </p:cNvPr>
          <p:cNvSpPr txBox="1">
            <a:spLocks/>
          </p:cNvSpPr>
          <p:nvPr/>
        </p:nvSpPr>
        <p:spPr>
          <a:xfrm>
            <a:off x="77983" y="4106597"/>
            <a:ext cx="6958940" cy="1160607"/>
          </a:xfrm>
          <a:prstGeom prst="rect">
            <a:avLst/>
          </a:prstGeom>
        </p:spPr>
        <p:txBody>
          <a:bodyPr vert="horz" lIns="51435" tIns="25719" rIns="51435" bIns="25719" rtlCol="0">
            <a:no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>
              <a:lnSpc>
                <a:spcPct val="10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3-1. Male ST rats are sensitive to Pavlovian Outcome Devaluation for lever responding, which is blocked by intra-DMS Rimonabant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ata are represented as within-subject individual data (lines) and group data (bars; mean ± SEM). Rats received intra-DMS injections of either vehicle (left) or rimonabant (right) 10 minutes prior to probe test. We observed a significant Outcome Value X Treatment X Tracking X Sex interaction for lever presses.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A,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B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 ST rats, we observe a significant Outcome Value X Treatment X Sex interaction on lever presses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A,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 Male ST rats we observed a marginal Outcome Value X Treatment interaction (p=0.073).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B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 ST Female rats there were no main effects or interactions. We then performed a parallel analysis in our GT/INT rats.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C, 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 GT/INT rats, we did not observe any significant main effects or interactions. #p=0.054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0359288-0EA3-BC8D-72DA-5E02708F173B}"/>
              </a:ext>
            </a:extLst>
          </p:cNvPr>
          <p:cNvSpPr txBox="1"/>
          <p:nvPr/>
        </p:nvSpPr>
        <p:spPr>
          <a:xfrm>
            <a:off x="829570" y="1880623"/>
            <a:ext cx="250746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1" b="1" u="sng" dirty="0">
                <a:latin typeface="Arial" panose="020B0604020202020204" pitchFamily="34" charset="0"/>
                <a:cs typeface="Arial" panose="020B0604020202020204" pitchFamily="34" charset="0"/>
              </a:rPr>
              <a:t>Goal-tracking/</a:t>
            </a:r>
            <a:r>
              <a:rPr lang="en-US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Intermediate</a:t>
            </a:r>
            <a:r>
              <a:rPr lang="en-US" sz="1051" b="1" u="sng" dirty="0">
                <a:latin typeface="Arial" panose="020B0604020202020204" pitchFamily="34" charset="0"/>
                <a:cs typeface="Arial" panose="020B0604020202020204" pitchFamily="34" charset="0"/>
              </a:rPr>
              <a:t> Rat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DAAC0F9-6A52-655B-972F-40311C495A18}"/>
              </a:ext>
            </a:extLst>
          </p:cNvPr>
          <p:cNvSpPr txBox="1"/>
          <p:nvPr/>
        </p:nvSpPr>
        <p:spPr>
          <a:xfrm>
            <a:off x="1251560" y="0"/>
            <a:ext cx="14334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Sign-tracking</a:t>
            </a:r>
            <a:r>
              <a:rPr lang="en-US" sz="1051" b="1" u="sng" dirty="0">
                <a:latin typeface="Arial" panose="020B0604020202020204" pitchFamily="34" charset="0"/>
                <a:cs typeface="Arial" panose="020B0604020202020204" pitchFamily="34" charset="0"/>
              </a:rPr>
              <a:t> Rats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9679671-BEDD-747A-CCEA-CEEE86F7CF0C}"/>
              </a:ext>
            </a:extLst>
          </p:cNvPr>
          <p:cNvSpPr txBox="1"/>
          <p:nvPr/>
        </p:nvSpPr>
        <p:spPr>
          <a:xfrm>
            <a:off x="947827" y="2238204"/>
            <a:ext cx="1419656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1" b="1" dirty="0">
                <a:latin typeface="Arial" panose="020B0604020202020204" pitchFamily="34" charset="0"/>
                <a:cs typeface="Arial" panose="020B0604020202020204" pitchFamily="34" charset="0"/>
              </a:rPr>
              <a:t>Male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518F700-6A02-DC4D-1573-58DD9C804D34}"/>
              </a:ext>
            </a:extLst>
          </p:cNvPr>
          <p:cNvSpPr txBox="1"/>
          <p:nvPr/>
        </p:nvSpPr>
        <p:spPr>
          <a:xfrm>
            <a:off x="2378458" y="2238204"/>
            <a:ext cx="1519441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1" b="1" dirty="0">
                <a:latin typeface="Arial" panose="020B0604020202020204" pitchFamily="34" charset="0"/>
                <a:cs typeface="Arial" panose="020B0604020202020204" pitchFamily="34" charset="0"/>
              </a:rPr>
              <a:t>Female 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6C45FC5-BBFD-FC2A-C381-BC144DA6FE10}"/>
              </a:ext>
            </a:extLst>
          </p:cNvPr>
          <p:cNvSpPr txBox="1"/>
          <p:nvPr/>
        </p:nvSpPr>
        <p:spPr>
          <a:xfrm>
            <a:off x="81270" y="2044716"/>
            <a:ext cx="913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D6FD465-068E-FC3D-0072-5292A300E7A7}"/>
              </a:ext>
            </a:extLst>
          </p:cNvPr>
          <p:cNvSpPr txBox="1"/>
          <p:nvPr/>
        </p:nvSpPr>
        <p:spPr>
          <a:xfrm>
            <a:off x="1991959" y="2046223"/>
            <a:ext cx="913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187007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 descr="A screenshot of a video game&#10;&#10;Description automatically generated">
            <a:extLst>
              <a:ext uri="{FF2B5EF4-FFF2-40B4-BE49-F238E27FC236}">
                <a16:creationId xmlns:a16="http://schemas.microsoft.com/office/drawing/2014/main" id="{CBBDD056-731E-8F19-6E53-3F0B33CC103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" t="60311" r="23447" b="236"/>
          <a:stretch/>
        </p:blipFill>
        <p:spPr>
          <a:xfrm>
            <a:off x="0" y="2105220"/>
            <a:ext cx="3443734" cy="1748338"/>
          </a:xfrm>
          <a:prstGeom prst="rect">
            <a:avLst/>
          </a:prstGeom>
        </p:spPr>
      </p:pic>
      <p:sp>
        <p:nvSpPr>
          <p:cNvPr id="13" name="Content Placeholder 2">
            <a:extLst>
              <a:ext uri="{FF2B5EF4-FFF2-40B4-BE49-F238E27FC236}">
                <a16:creationId xmlns:a16="http://schemas.microsoft.com/office/drawing/2014/main" id="{3B5EA425-1D9B-92BE-A7DF-09BB8098C5B4}"/>
              </a:ext>
            </a:extLst>
          </p:cNvPr>
          <p:cNvSpPr txBox="1">
            <a:spLocks/>
          </p:cNvSpPr>
          <p:nvPr/>
        </p:nvSpPr>
        <p:spPr>
          <a:xfrm>
            <a:off x="135686" y="4163552"/>
            <a:ext cx="6858000" cy="1160607"/>
          </a:xfrm>
          <a:prstGeom prst="rect">
            <a:avLst/>
          </a:prstGeom>
        </p:spPr>
        <p:txBody>
          <a:bodyPr vert="horz" lIns="51435" tIns="25719" rIns="51435" bIns="25719" rtlCol="0">
            <a:no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>
              <a:lnSpc>
                <a:spcPct val="10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3-2. Male GT/INT rats are sensitive to Pavlovian Outcome Devaluation for food cup responding, which is blocked by intra-DMS Rimonabant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ata are represented as within-subject individual data (lines) and group data (bars; mean ± SEM). Rats received intra-DMS injections of either vehicle (left) or rimonabant (right) 10 minutes prior to probe test. For all rats, we observed a significant Outcome Value X Treatment interaction and main effects of Sex and Tracking.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A,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B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 ST rats, we did not observe any significant main effects or interactions. We then performed a parallel analysis in our GT/INT rats.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C, 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 GT/INT rats, we observe an Outcome Value X Treatment interaction, and a main effect of Sex.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C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 male GT/INT rats, we observed a significant Outcome Value X Treatment interaction.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D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 female GT/INTs, we did not observe any significant interactions or main effects.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p&lt;0.05</a:t>
            </a:r>
          </a:p>
        </p:txBody>
      </p:sp>
      <p:pic>
        <p:nvPicPr>
          <p:cNvPr id="24" name="Picture 23" descr="A screenshot of a video game&#10;&#10;Description automatically generated">
            <a:extLst>
              <a:ext uri="{FF2B5EF4-FFF2-40B4-BE49-F238E27FC236}">
                <a16:creationId xmlns:a16="http://schemas.microsoft.com/office/drawing/2014/main" id="{59151876-B8F5-A185-9261-981939E80BC9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999" t="10355" r="3112" b="67386"/>
          <a:stretch/>
        </p:blipFill>
        <p:spPr>
          <a:xfrm>
            <a:off x="3255540" y="223188"/>
            <a:ext cx="914400" cy="49487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803ABC4-897E-30E9-2372-A2C28389A45E}"/>
              </a:ext>
            </a:extLst>
          </p:cNvPr>
          <p:cNvSpPr txBox="1"/>
          <p:nvPr/>
        </p:nvSpPr>
        <p:spPr>
          <a:xfrm>
            <a:off x="793721" y="2533748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D3BC3D7-13C3-8ED8-4B53-4D1E915EED23}"/>
              </a:ext>
            </a:extLst>
          </p:cNvPr>
          <p:cNvSpPr txBox="1"/>
          <p:nvPr/>
        </p:nvSpPr>
        <p:spPr>
          <a:xfrm>
            <a:off x="1024794" y="387415"/>
            <a:ext cx="606025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1" b="1" dirty="0">
                <a:latin typeface="Arial" panose="020B0604020202020204" pitchFamily="34" charset="0"/>
                <a:cs typeface="Arial" panose="020B0604020202020204" pitchFamily="34" charset="0"/>
              </a:rPr>
              <a:t>Male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F456C58-B628-4FA4-6DCE-6227609253CB}"/>
              </a:ext>
            </a:extLst>
          </p:cNvPr>
          <p:cNvSpPr txBox="1"/>
          <p:nvPr/>
        </p:nvSpPr>
        <p:spPr>
          <a:xfrm>
            <a:off x="2443831" y="387414"/>
            <a:ext cx="1511771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1" b="1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  <a:r>
              <a:rPr lang="en-US" sz="591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FB182B4-3466-CBBA-9D22-F50D45C7590D}"/>
              </a:ext>
            </a:extLst>
          </p:cNvPr>
          <p:cNvSpPr txBox="1"/>
          <p:nvPr/>
        </p:nvSpPr>
        <p:spPr>
          <a:xfrm>
            <a:off x="135686" y="192455"/>
            <a:ext cx="913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B4C1130-2722-3A8B-DCE1-71ADAF2623DC}"/>
              </a:ext>
            </a:extLst>
          </p:cNvPr>
          <p:cNvSpPr txBox="1"/>
          <p:nvPr/>
        </p:nvSpPr>
        <p:spPr>
          <a:xfrm>
            <a:off x="2049662" y="188785"/>
            <a:ext cx="913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3CC4C00-591C-F35C-3F7D-A68D89AA57E4}"/>
              </a:ext>
            </a:extLst>
          </p:cNvPr>
          <p:cNvSpPr txBox="1"/>
          <p:nvPr/>
        </p:nvSpPr>
        <p:spPr>
          <a:xfrm>
            <a:off x="887273" y="1880623"/>
            <a:ext cx="250746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1" b="1" u="sng" dirty="0">
                <a:latin typeface="Arial" panose="020B0604020202020204" pitchFamily="34" charset="0"/>
                <a:cs typeface="Arial" panose="020B0604020202020204" pitchFamily="34" charset="0"/>
              </a:rPr>
              <a:t>Goal-tracking/</a:t>
            </a:r>
            <a:r>
              <a:rPr lang="en-US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Intermediate</a:t>
            </a:r>
            <a:r>
              <a:rPr lang="en-US" sz="1051" b="1" u="sng" dirty="0">
                <a:latin typeface="Arial" panose="020B0604020202020204" pitchFamily="34" charset="0"/>
                <a:cs typeface="Arial" panose="020B0604020202020204" pitchFamily="34" charset="0"/>
              </a:rPr>
              <a:t> Rat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96866E2-808F-A595-FC31-87D7FC9BC066}"/>
              </a:ext>
            </a:extLst>
          </p:cNvPr>
          <p:cNvSpPr txBox="1"/>
          <p:nvPr/>
        </p:nvSpPr>
        <p:spPr>
          <a:xfrm>
            <a:off x="1309263" y="0"/>
            <a:ext cx="14334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Sign-tracking</a:t>
            </a:r>
            <a:r>
              <a:rPr lang="en-US" sz="1051" b="1" u="sng" dirty="0">
                <a:latin typeface="Arial" panose="020B0604020202020204" pitchFamily="34" charset="0"/>
                <a:cs typeface="Arial" panose="020B0604020202020204" pitchFamily="34" charset="0"/>
              </a:rPr>
              <a:t> Rats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19C1314-C718-A2DF-3E66-A95D998FA2A3}"/>
              </a:ext>
            </a:extLst>
          </p:cNvPr>
          <p:cNvSpPr txBox="1"/>
          <p:nvPr/>
        </p:nvSpPr>
        <p:spPr>
          <a:xfrm>
            <a:off x="1005530" y="2238204"/>
            <a:ext cx="1419656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1" b="1" dirty="0">
                <a:latin typeface="Arial" panose="020B0604020202020204" pitchFamily="34" charset="0"/>
                <a:cs typeface="Arial" panose="020B0604020202020204" pitchFamily="34" charset="0"/>
              </a:rPr>
              <a:t>Male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B301435-1524-6AC7-D5ED-68FAE63B10FB}"/>
              </a:ext>
            </a:extLst>
          </p:cNvPr>
          <p:cNvSpPr txBox="1"/>
          <p:nvPr/>
        </p:nvSpPr>
        <p:spPr>
          <a:xfrm>
            <a:off x="2436161" y="2238204"/>
            <a:ext cx="1519441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1" b="1" dirty="0">
                <a:latin typeface="Arial" panose="020B0604020202020204" pitchFamily="34" charset="0"/>
                <a:cs typeface="Arial" panose="020B0604020202020204" pitchFamily="34" charset="0"/>
              </a:rPr>
              <a:t>Female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6C0525D-96B1-61AE-2289-123DA3D5231F}"/>
              </a:ext>
            </a:extLst>
          </p:cNvPr>
          <p:cNvSpPr txBox="1"/>
          <p:nvPr/>
        </p:nvSpPr>
        <p:spPr>
          <a:xfrm>
            <a:off x="138973" y="2044716"/>
            <a:ext cx="913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9DC64D0-194E-F123-6B3D-0E0905FADA87}"/>
              </a:ext>
            </a:extLst>
          </p:cNvPr>
          <p:cNvSpPr txBox="1"/>
          <p:nvPr/>
        </p:nvSpPr>
        <p:spPr>
          <a:xfrm>
            <a:off x="2049662" y="2046223"/>
            <a:ext cx="913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18" name="Picture 17" descr="A screenshot of a video game&#10;&#10;Description automatically generated">
            <a:extLst>
              <a:ext uri="{FF2B5EF4-FFF2-40B4-BE49-F238E27FC236}">
                <a16:creationId xmlns:a16="http://schemas.microsoft.com/office/drawing/2014/main" id="{D301031F-831B-ADDD-FDFC-8E1C759DFF91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91" t="61684" r="22235" b="-539"/>
          <a:stretch/>
        </p:blipFill>
        <p:spPr>
          <a:xfrm>
            <a:off x="59046" y="319198"/>
            <a:ext cx="3444273" cy="17270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92697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f776233f-271f-424f-b4f0-87214baa65c2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15610F52DFB75D4FA4DD523BFE925AF2" ma:contentTypeVersion="10" ma:contentTypeDescription="Create a new document." ma:contentTypeScope="" ma:versionID="af04d2f0ca5d7312b6e6f700e94cb04c">
  <xsd:schema xmlns:xsd="http://www.w3.org/2001/XMLSchema" xmlns:xs="http://www.w3.org/2001/XMLSchema" xmlns:p="http://schemas.microsoft.com/office/2006/metadata/properties" xmlns:ns3="f776233f-271f-424f-b4f0-87214baa65c2" xmlns:ns4="a9710b39-b9b3-4f1b-a963-9de5781cf47f" targetNamespace="http://schemas.microsoft.com/office/2006/metadata/properties" ma:root="true" ma:fieldsID="d9a00da39e338e3e65a45d3021667c39" ns3:_="" ns4:_="">
    <xsd:import namespace="f776233f-271f-424f-b4f0-87214baa65c2"/>
    <xsd:import namespace="a9710b39-b9b3-4f1b-a963-9de5781cf47f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3:_activity" minOccurs="0"/>
                <xsd:element ref="ns3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776233f-271f-424f-b4f0-87214baa65c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KeyPoints" ma:index="14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5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_activity" ma:index="16" nillable="true" ma:displayName="_activity" ma:hidden="true" ma:internalName="_activity">
      <xsd:simpleType>
        <xsd:restriction base="dms:Note"/>
      </xsd:simpleType>
    </xsd:element>
    <xsd:element name="MediaServiceObjectDetectorVersions" ma:index="17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9710b39-b9b3-4f1b-a963-9de5781cf47f" elementFormDefault="qualified">
    <xsd:import namespace="http://schemas.microsoft.com/office/2006/documentManagement/types"/>
    <xsd:import namespace="http://schemas.microsoft.com/office/infopath/2007/PartnerControls"/>
    <xsd:element name="SharedWithUsers" ma:index="11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2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3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81A7D843-7CF2-4131-A0DC-A8DC6C008990}">
  <ds:schemaRefs>
    <ds:schemaRef ds:uri="http://purl.org/dc/terms/"/>
    <ds:schemaRef ds:uri="http://schemas.microsoft.com/office/2006/metadata/properties"/>
    <ds:schemaRef ds:uri="http://purl.org/dc/elements/1.1/"/>
    <ds:schemaRef ds:uri="http://purl.org/dc/dcmitype/"/>
    <ds:schemaRef ds:uri="http://schemas.microsoft.com/office/infopath/2007/PartnerControls"/>
    <ds:schemaRef ds:uri="http://www.w3.org/XML/1998/namespace"/>
    <ds:schemaRef ds:uri="http://schemas.openxmlformats.org/package/2006/metadata/core-properties"/>
    <ds:schemaRef ds:uri="http://schemas.microsoft.com/office/2006/documentManagement/types"/>
    <ds:schemaRef ds:uri="a9710b39-b9b3-4f1b-a963-9de5781cf47f"/>
    <ds:schemaRef ds:uri="f776233f-271f-424f-b4f0-87214baa65c2"/>
  </ds:schemaRefs>
</ds:datastoreItem>
</file>

<file path=customXml/itemProps2.xml><?xml version="1.0" encoding="utf-8"?>
<ds:datastoreItem xmlns:ds="http://schemas.openxmlformats.org/officeDocument/2006/customXml" ds:itemID="{D677D5EC-9192-413F-8F00-7644B28AB285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DBE76041-748B-4EDF-912B-6EE42CDF5D9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f776233f-271f-424f-b4f0-87214baa65c2"/>
    <ds:schemaRef ds:uri="a9710b39-b9b3-4f1b-a963-9de5781cf47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175</TotalTime>
  <Words>613</Words>
  <Application>Microsoft Office PowerPoint</Application>
  <PresentationFormat>Custom</PresentationFormat>
  <Paragraphs>3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ptos</vt:lpstr>
      <vt:lpstr>Arial</vt:lpstr>
      <vt:lpstr>Calibri</vt:lpstr>
      <vt:lpstr>Calibri Light</vt:lpstr>
      <vt:lpstr>Office 2013 - 2022 Theme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</dc:creator>
  <cp:lastModifiedBy>Ms. Catherine A. Stapf</cp:lastModifiedBy>
  <cp:revision>169</cp:revision>
  <dcterms:created xsi:type="dcterms:W3CDTF">2022-09-08T15:05:58Z</dcterms:created>
  <dcterms:modified xsi:type="dcterms:W3CDTF">2024-08-05T16:51:5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5610F52DFB75D4FA4DD523BFE925AF2</vt:lpwstr>
  </property>
</Properties>
</file>